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 showGuides="1">
      <p:cViewPr varScale="1">
        <p:scale>
          <a:sx n="173" d="100"/>
          <a:sy n="173" d="100"/>
        </p:scale>
        <p:origin x="192" y="59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image" Target="../media/image2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7AF598C-9170-4918-A8FB-19E11E03948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AC6CB203-0968-4CD9-85EC-2F9A993768A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D31BA54-9BCB-4891-8AAF-B5DFA27527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57108-A206-4563-9E60-B46C83907311}" type="datetimeFigureOut">
              <a:rPr lang="de-DE" smtClean="0"/>
              <a:t>19.09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51E4FCE-9F7F-42E9-85B6-2CF442F03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3582EA2-BAB6-41E1-8B55-3DFA7F27E5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CBDD4-3929-4A80-BF94-55230A7C39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1417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B30BAFD-C082-44EB-A5C6-F0805326C2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5218E277-263F-47F0-BBB0-63ED908982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D868F3D-84C8-4837-99A7-92402BC1D7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57108-A206-4563-9E60-B46C83907311}" type="datetimeFigureOut">
              <a:rPr lang="de-DE" smtClean="0"/>
              <a:t>19.09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90559AD-5AF2-4F58-885E-721014881D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B8AD49C-0BA3-4EA8-9A00-4D6A505FD4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CBDD4-3929-4A80-BF94-55230A7C39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000420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E25EEBE9-12C2-4CA3-B65E-7081118F6CA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60274B99-FE74-4205-BD4B-3F32B0FD19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37A45C0-83A4-4918-A21B-C660B0F56C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57108-A206-4563-9E60-B46C83907311}" type="datetimeFigureOut">
              <a:rPr lang="de-DE" smtClean="0"/>
              <a:t>19.09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CC426FA-9C04-417F-8809-08B72DE48D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98BFCAB-83AC-4864-9A55-647F218D8E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CBDD4-3929-4A80-BF94-55230A7C39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272445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76ACB3C-892F-4496-886F-B9FBD7790E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C77E0D9F-6302-4AE6-873F-9F3817523A0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54BFE2A-F4A1-46E2-8580-68883AEFD8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57108-A206-4563-9E60-B46C83907311}" type="datetimeFigureOut">
              <a:rPr lang="de-DE" smtClean="0"/>
              <a:t>19.09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1D1FB6D-EEBD-40F9-9E74-44FC6DE7FB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3C8A2FB-A25A-45D3-A784-182DA39635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CBDD4-3929-4A80-BF94-55230A7C39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26020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416802B-2CB4-4FFE-A75E-767B1034FB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32F12D48-C035-4F8A-A869-9BB32574B9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7E83EB4-4EDB-45FA-848F-127ADEC7AC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57108-A206-4563-9E60-B46C83907311}" type="datetimeFigureOut">
              <a:rPr lang="de-DE" smtClean="0"/>
              <a:t>19.09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C312AC9-316A-402B-B077-FD7AF0C9D9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EBF6BF5-33E3-46BB-B4B8-51A0225BF7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CBDD4-3929-4A80-BF94-55230A7C39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808437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06BE049-345A-4154-956F-49ABCAD1E3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870FC76-2409-4E6A-B876-83D6518E97A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AD05851C-1D0A-4877-8C9C-4A7FDC7175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BB693E0-9769-4F1E-BE3E-8BE4BFE2A9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57108-A206-4563-9E60-B46C83907311}" type="datetimeFigureOut">
              <a:rPr lang="de-DE" smtClean="0"/>
              <a:t>19.09.21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9F8C7A41-E94B-453E-ACDE-E112F1502A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51F16A76-67D5-4EE9-9AB0-37CA28EDC0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CBDD4-3929-4A80-BF94-55230A7C39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27219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4283F89-DEE4-487F-B46B-4FFD249566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5A30E8D-4941-4B4B-A450-64F902BCD9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7413C2A9-DE36-4206-ABA4-30B387C3D3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B569C191-7926-4F3C-857A-C97705F9913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17DF9A83-8313-4D22-BBD1-FC39031BD6D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74853F46-685E-4C29-B4D5-C800453674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57108-A206-4563-9E60-B46C83907311}" type="datetimeFigureOut">
              <a:rPr lang="de-DE" smtClean="0"/>
              <a:t>19.09.21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8B29FAC9-4F8A-40E7-B06C-8749098D19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039A49DC-5AE0-4CFB-A3F3-D99BA8FDD1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CBDD4-3929-4A80-BF94-55230A7C39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114736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F1CE32F-DB69-4D51-952E-A3497D5AD3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413426BE-D232-43A9-BA3D-E7A867AEFE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57108-A206-4563-9E60-B46C83907311}" type="datetimeFigureOut">
              <a:rPr lang="de-DE" smtClean="0"/>
              <a:t>19.09.21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CA89AFF6-28E7-414F-B89C-3D9416D4DA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B437E267-6C0A-43FF-89C9-9B3F2840A4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CBDD4-3929-4A80-BF94-55230A7C39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772370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7EDD2A45-77D3-4A31-A792-8CBCBA0C14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57108-A206-4563-9E60-B46C83907311}" type="datetimeFigureOut">
              <a:rPr lang="de-DE" smtClean="0"/>
              <a:t>19.09.21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76544D4E-0377-4126-8140-1283818C13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ABFEBE39-306A-41A6-B803-891C43C6D8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CBDD4-3929-4A80-BF94-55230A7C39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510094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907205E-6A0B-4B5F-B0E9-AA1B657555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C22CBD91-4831-4564-BB5A-3D275B40EB9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5B07BC9D-6D49-498F-9883-5F71863ECE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8F4768C5-71D1-4B63-B929-5B1E184C9C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57108-A206-4563-9E60-B46C83907311}" type="datetimeFigureOut">
              <a:rPr lang="de-DE" smtClean="0"/>
              <a:t>19.09.21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0CF7673-7A1D-4612-AB9F-24B69C92E8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B7221CA9-939D-43F2-91F4-243512F8C1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CBDD4-3929-4A80-BF94-55230A7C39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05312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10CA4C5-2BA8-4F1D-A480-449D82E898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281A8581-55CE-4A12-8407-FAD19A88A9D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F46B50AE-CE74-4B25-B675-66F649C4ED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6656A291-F75A-4452-833F-B8C88C2D12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57108-A206-4563-9E60-B46C83907311}" type="datetimeFigureOut">
              <a:rPr lang="de-DE" smtClean="0"/>
              <a:t>19.09.21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DBF38CEC-1202-4ABA-B575-BDCE534347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ABFE8DB-F71A-4DE0-835D-C35B46A25F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CBDD4-3929-4A80-BF94-55230A7C39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08856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361506CA-C3E9-47DB-AF03-A0CFD9270C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9982E74A-E3DB-4ED4-9386-531A967796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260F783-55C8-4F9F-A2C2-655DBB014CF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E57108-A206-4563-9E60-B46C83907311}" type="datetimeFigureOut">
              <a:rPr lang="de-DE" smtClean="0"/>
              <a:t>19.09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9CFF2EB-94DF-4E1B-8AF0-BF944CCDCDD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A8E8509-3375-49B9-AD1B-9CE8F2DC1BF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0CBDD4-3929-4A80-BF94-55230A7C39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91591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.xlsx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1.xlsx"/><Relationship Id="rId7" Type="http://schemas.openxmlformats.org/officeDocument/2006/relationships/image" Target="../media/image4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3.emf"/><Relationship Id="rId5" Type="http://schemas.openxmlformats.org/officeDocument/2006/relationships/package" Target="../embeddings/Microsoft_Excel-Arbeitsblatt2.xlsx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kt 4">
            <a:extLst>
              <a:ext uri="{FF2B5EF4-FFF2-40B4-BE49-F238E27FC236}">
                <a16:creationId xmlns:a16="http://schemas.microsoft.com/office/drawing/2014/main" id="{6D964B1C-9ABA-5442-960C-B9871F63B1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04439551"/>
              </p:ext>
            </p:extLst>
          </p:nvPr>
        </p:nvGraphicFramePr>
        <p:xfrm>
          <a:off x="-17876" y="56707"/>
          <a:ext cx="12209876" cy="67481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7" name="Arbeitsblatt" r:id="rId3" imgW="12928600" imgH="5334000" progId="Excel.Sheet.12">
                  <p:embed/>
                </p:oleObj>
              </mc:Choice>
              <mc:Fallback>
                <p:oleObj name="Arbeitsblatt" r:id="rId3" imgW="12928600" imgH="533400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-17876" y="56707"/>
                        <a:ext cx="12209876" cy="674813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9387421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pieren 5">
            <a:extLst>
              <a:ext uri="{FF2B5EF4-FFF2-40B4-BE49-F238E27FC236}">
                <a16:creationId xmlns:a16="http://schemas.microsoft.com/office/drawing/2014/main" id="{1BC4F8A6-8263-5A45-B1DA-FD20B6500A3F}"/>
              </a:ext>
            </a:extLst>
          </p:cNvPr>
          <p:cNvGrpSpPr/>
          <p:nvPr/>
        </p:nvGrpSpPr>
        <p:grpSpPr>
          <a:xfrm>
            <a:off x="162228" y="22122"/>
            <a:ext cx="11979349" cy="5252484"/>
            <a:chOff x="1524000" y="1873147"/>
            <a:chExt cx="9144000" cy="2671866"/>
          </a:xfrm>
        </p:grpSpPr>
        <p:graphicFrame>
          <p:nvGraphicFramePr>
            <p:cNvPr id="3" name="Objekt 2">
              <a:extLst>
                <a:ext uri="{FF2B5EF4-FFF2-40B4-BE49-F238E27FC236}">
                  <a16:creationId xmlns:a16="http://schemas.microsoft.com/office/drawing/2014/main" id="{5B5A1DC2-B50B-4B49-AECF-0C30654A757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515241852"/>
                </p:ext>
              </p:extLst>
            </p:nvPr>
          </p:nvGraphicFramePr>
          <p:xfrm>
            <a:off x="1524000" y="2317750"/>
            <a:ext cx="9144000" cy="22272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158" name="Arbeitsblatt" r:id="rId3" imgW="12928600" imgH="3149600" progId="Excel.Sheet.12">
                    <p:embed/>
                  </p:oleObj>
                </mc:Choice>
                <mc:Fallback>
                  <p:oleObj name="Arbeitsblatt" r:id="rId3" imgW="12928600" imgH="3149600" progId="Excel.Sheet.12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524000" y="2317750"/>
                          <a:ext cx="9144000" cy="22272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Objekt 4">
              <a:extLst>
                <a:ext uri="{FF2B5EF4-FFF2-40B4-BE49-F238E27FC236}">
                  <a16:creationId xmlns:a16="http://schemas.microsoft.com/office/drawing/2014/main" id="{27AC26D7-7059-0D4F-8D8D-B9DCEA5A937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65336970"/>
                </p:ext>
              </p:extLst>
            </p:nvPr>
          </p:nvGraphicFramePr>
          <p:xfrm>
            <a:off x="1524000" y="1873147"/>
            <a:ext cx="9144000" cy="4667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159" name="Arbeitsblatt" r:id="rId5" imgW="12928600" imgH="660400" progId="Excel.Sheet.12">
                    <p:embed/>
                  </p:oleObj>
                </mc:Choice>
                <mc:Fallback>
                  <p:oleObj name="Arbeitsblatt" r:id="rId5" imgW="12928600" imgH="660400" progId="Excel.Sheet.12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524000" y="1873147"/>
                          <a:ext cx="9144000" cy="4667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aphicFrame>
        <p:nvGraphicFramePr>
          <p:cNvPr id="10" name="Tabelle 9">
            <a:extLst>
              <a:ext uri="{FF2B5EF4-FFF2-40B4-BE49-F238E27FC236}">
                <a16:creationId xmlns:a16="http://schemas.microsoft.com/office/drawing/2014/main" id="{71B0CAF7-B126-4A46-867E-37AD2F35C62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64448722"/>
              </p:ext>
            </p:extLst>
          </p:nvPr>
        </p:nvGraphicFramePr>
        <p:xfrm>
          <a:off x="694175" y="5314433"/>
          <a:ext cx="8127999" cy="11125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38439">
                  <a:extLst>
                    <a:ext uri="{9D8B030D-6E8A-4147-A177-3AD203B41FA5}">
                      <a16:colId xmlns:a16="http://schemas.microsoft.com/office/drawing/2014/main" val="3455842228"/>
                    </a:ext>
                  </a:extLst>
                </a:gridCol>
                <a:gridCol w="2424223">
                  <a:extLst>
                    <a:ext uri="{9D8B030D-6E8A-4147-A177-3AD203B41FA5}">
                      <a16:colId xmlns:a16="http://schemas.microsoft.com/office/drawing/2014/main" val="4267708298"/>
                    </a:ext>
                  </a:extLst>
                </a:gridCol>
                <a:gridCol w="5065337">
                  <a:extLst>
                    <a:ext uri="{9D8B030D-6E8A-4147-A177-3AD203B41FA5}">
                      <a16:colId xmlns:a16="http://schemas.microsoft.com/office/drawing/2014/main" val="1627798095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egend:  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1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 = </a:t>
                      </a:r>
                      <a:r>
                        <a:rPr lang="de-DE" sz="1100" b="0" dirty="0" err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information</a:t>
                      </a:r>
                      <a:r>
                        <a:rPr lang="de-DE" sz="11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de-DE" sz="1100" b="0" dirty="0" err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technology</a:t>
                      </a:r>
                      <a:r>
                        <a:rPr lang="de-DE" sz="11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(IT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1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 = German Federal Law on </a:t>
                      </a:r>
                      <a:r>
                        <a:rPr lang="de-DE" sz="1100" b="0" dirty="0" err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the</a:t>
                      </a:r>
                      <a:r>
                        <a:rPr lang="de-DE" sz="11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de-DE" sz="1100" b="0" dirty="0" err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revention</a:t>
                      </a:r>
                      <a:r>
                        <a:rPr lang="de-DE" sz="11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de-DE" sz="1100" b="0" dirty="0" err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of</a:t>
                      </a:r>
                      <a:r>
                        <a:rPr lang="de-DE" sz="11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de-DE" sz="1100" b="0" dirty="0" err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Infectious</a:t>
                      </a:r>
                      <a:r>
                        <a:rPr lang="de-DE" sz="11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de-DE" sz="1100" b="0" dirty="0" err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Diseases</a:t>
                      </a:r>
                      <a:r>
                        <a:rPr lang="de-DE" sz="11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in </a:t>
                      </a:r>
                      <a:r>
                        <a:rPr lang="de-DE" sz="1100" b="0" dirty="0" err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Humans</a:t>
                      </a:r>
                      <a:r>
                        <a:rPr lang="de-DE" sz="1100" b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(IfSG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1165311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de-DE" dirty="0"/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r>
                        <a:rPr lang="de-DE" sz="11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 = </a:t>
                      </a:r>
                      <a:r>
                        <a:rPr lang="de-DE" sz="1100" dirty="0" err="1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onPharmaceutical</a:t>
                      </a:r>
                      <a:r>
                        <a:rPr lang="de-DE" sz="11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de-DE" sz="1100" dirty="0" err="1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Interventions</a:t>
                      </a:r>
                      <a:r>
                        <a:rPr lang="de-DE" sz="11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(e.g. face-</a:t>
                      </a:r>
                      <a:r>
                        <a:rPr lang="de-DE" sz="1100" dirty="0" err="1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asks</a:t>
                      </a:r>
                      <a:r>
                        <a:rPr lang="de-DE" sz="11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, </a:t>
                      </a:r>
                      <a:r>
                        <a:rPr lang="de-DE" sz="1100" dirty="0" err="1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ocial</a:t>
                      </a:r>
                      <a:r>
                        <a:rPr lang="de-DE" sz="11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de-DE" sz="1100" dirty="0" err="1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distancing</a:t>
                      </a:r>
                      <a:r>
                        <a:rPr lang="de-DE" sz="11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, etc.), also </a:t>
                      </a:r>
                      <a:r>
                        <a:rPr lang="de-DE" sz="1100" dirty="0" err="1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known</a:t>
                      </a:r>
                      <a:r>
                        <a:rPr lang="de-DE" sz="11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de-DE" sz="1100" dirty="0" err="1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s</a:t>
                      </a:r>
                      <a:r>
                        <a:rPr lang="de-DE" sz="11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de-DE" sz="1100" dirty="0" err="1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ommunity</a:t>
                      </a:r>
                      <a:r>
                        <a:rPr lang="de-DE" sz="11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de-DE" sz="1100" dirty="0" err="1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itigation</a:t>
                      </a:r>
                      <a:r>
                        <a:rPr lang="de-DE" sz="11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de-DE" sz="1100" dirty="0" err="1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trategies</a:t>
                      </a:r>
                      <a:endParaRPr lang="de-DE" sz="11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 dirty="0"/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294485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de-DE" dirty="0"/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11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olor </a:t>
                      </a:r>
                      <a:r>
                        <a:rPr lang="de-DE" sz="1100" dirty="0" err="1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ode</a:t>
                      </a:r>
                      <a:r>
                        <a:rPr lang="de-DE" sz="11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de-DE" sz="1100" dirty="0" err="1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to</a:t>
                      </a:r>
                      <a:r>
                        <a:rPr lang="de-DE" sz="11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score </a:t>
                      </a:r>
                      <a:r>
                        <a:rPr lang="de-DE" sz="1100" dirty="0" err="1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the</a:t>
                      </a:r>
                      <a:r>
                        <a:rPr lang="de-DE" sz="11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de-DE" sz="1100" dirty="0" err="1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atrix</a:t>
                      </a:r>
                      <a:r>
                        <a:rPr lang="de-DE" sz="11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: 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dirty="0"/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53049104"/>
                  </a:ext>
                </a:extLst>
              </a:tr>
            </a:tbl>
          </a:graphicData>
        </a:graphic>
      </p:graphicFrame>
      <p:pic>
        <p:nvPicPr>
          <p:cNvPr id="11" name="Grafik 10">
            <a:extLst>
              <a:ext uri="{FF2B5EF4-FFF2-40B4-BE49-F238E27FC236}">
                <a16:creationId xmlns:a16="http://schemas.microsoft.com/office/drawing/2014/main" id="{784D7414-076A-4468-A87C-8243C38260D5}"/>
              </a:ext>
            </a:extLst>
          </p:cNvPr>
          <p:cNvPicPr/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8800" y="6126506"/>
            <a:ext cx="5553374" cy="2441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53760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4</Words>
  <Application>Microsoft Macintosh PowerPoint</Application>
  <PresentationFormat>Breitbild</PresentationFormat>
  <Paragraphs>5</Paragraphs>
  <Slides>2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Arbeitsblatt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win</dc:creator>
  <cp:lastModifiedBy>MB</cp:lastModifiedBy>
  <cp:revision>12</cp:revision>
  <dcterms:created xsi:type="dcterms:W3CDTF">2021-02-06T17:06:50Z</dcterms:created>
  <dcterms:modified xsi:type="dcterms:W3CDTF">2021-09-19T16:19:51Z</dcterms:modified>
</cp:coreProperties>
</file>